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7245D-EF61-4BD2-A0CE-5A5468FE37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576D7A-3F33-45B0-AF58-3C4B6D8619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D088A-C044-4B1D-9E45-62FA30C92C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4FF9A-71D4-4CD9-AE4A-6F07059AA9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F1A828-FEFC-44F6-9551-747E79A27B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554F6D-2AF3-4C71-BBB8-31CA9CA252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15DE9-B378-4E70-A1FE-C4786D6695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60EF00-124C-4621-B81B-398F5367F6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F8570-821C-4311-AFFB-464ACB1289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CBCD59-8DA0-4692-8F9B-B4FE078751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82E22-860A-454C-ABF4-E206480E94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AAD2D-AD7F-4D3F-824E-F42F039577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394074-068F-4655-89EA-D549A8675EAA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正方形/長方形 1"/>
          <p:cNvSpPr/>
          <p:nvPr/>
        </p:nvSpPr>
        <p:spPr>
          <a:xfrm>
            <a:off x="611280" y="2274840"/>
            <a:ext cx="81374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76320" indent="-76320"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Supplemental Figure S6: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 Number of sequences in the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Fragaria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assembled genomes that showed significant similarity to (a) 34,809 candidate genes, and (b) 104 agriculturally important genes identified on the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F. vesca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 genome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SimSun"/>
              </a:rPr>
              <a:t>13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. BLAT and FASTA36 were used for the similarity searches to the 34,809 genes and the 104 genes, respectively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テキスト ボックス 3"/>
          <p:cNvSpPr/>
          <p:nvPr/>
        </p:nvSpPr>
        <p:spPr>
          <a:xfrm>
            <a:off x="925560" y="114480"/>
            <a:ext cx="709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a) The result of similarity search (BLAT) against the 34,809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. vesca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andidate genes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5" descr=""/>
          <p:cNvPicPr/>
          <p:nvPr/>
        </p:nvPicPr>
        <p:blipFill>
          <a:blip r:embed="rId1"/>
          <a:stretch/>
        </p:blipFill>
        <p:spPr>
          <a:xfrm>
            <a:off x="108000" y="720720"/>
            <a:ext cx="8924760" cy="5835600"/>
          </a:xfrm>
          <a:prstGeom prst="rect">
            <a:avLst/>
          </a:prstGeom>
          <a:ln w="0">
            <a:noFill/>
          </a:ln>
        </p:spPr>
      </p:pic>
      <p:sp>
        <p:nvSpPr>
          <p:cNvPr id="44" name="テキスト ボックス 2"/>
          <p:cNvSpPr/>
          <p:nvPr/>
        </p:nvSpPr>
        <p:spPr>
          <a:xfrm rot="16200000">
            <a:off x="1198800" y="5959080"/>
            <a:ext cx="5616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o hi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テキスト ボックス 4"/>
          <p:cNvSpPr/>
          <p:nvPr/>
        </p:nvSpPr>
        <p:spPr>
          <a:xfrm>
            <a:off x="711720" y="115920"/>
            <a:ext cx="7889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(b) The result of similarity search (FASTA36 program) against the 104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. vesca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andidate genes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5" descr=""/>
          <p:cNvPicPr/>
          <p:nvPr/>
        </p:nvPicPr>
        <p:blipFill>
          <a:blip r:embed="rId1"/>
          <a:stretch/>
        </p:blipFill>
        <p:spPr>
          <a:xfrm>
            <a:off x="108000" y="690480"/>
            <a:ext cx="8942400" cy="5834160"/>
          </a:xfrm>
          <a:prstGeom prst="rect">
            <a:avLst/>
          </a:prstGeom>
          <a:ln w="0">
            <a:noFill/>
          </a:ln>
        </p:spPr>
      </p:pic>
      <p:sp>
        <p:nvSpPr>
          <p:cNvPr id="47" name="テキスト ボックス 5"/>
          <p:cNvSpPr/>
          <p:nvPr/>
        </p:nvSpPr>
        <p:spPr>
          <a:xfrm rot="16200000">
            <a:off x="982800" y="5959080"/>
            <a:ext cx="5616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o hi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22T12:41:15Z</dcterms:created>
  <dc:creator>Hideki Hirakawa</dc:creator>
  <dc:description/>
  <dc:language>en-US</dc:language>
  <cp:lastModifiedBy>Hideki Hirakawa</cp:lastModifiedBy>
  <dcterms:modified xsi:type="dcterms:W3CDTF">2013-11-07T09:23:51Z</dcterms:modified>
  <cp:revision>9</cp:revision>
  <dc:subject/>
  <dc:title>PowerPoint プレゼンテーション</dc:title>
</cp:coreProperties>
</file>